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803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402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794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95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22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17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110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263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537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170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3725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B43C1E-94D6-764F-8570-C111BA6C8818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F493A-69A2-A643-AE2C-F3C3CF5998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083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wmf"/><Relationship Id="rId20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Relationship Id="rId22" Type="http://schemas.openxmlformats.org/officeDocument/2006/relationships/image" Target="../media/image10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38826276"/>
              </p:ext>
            </p:extLst>
          </p:nvPr>
        </p:nvGraphicFramePr>
        <p:xfrm>
          <a:off x="107184" y="1202405"/>
          <a:ext cx="2081254" cy="21612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Graph" r:id="rId3" imgW="3718080" imgH="2895840" progId="Origin50.Graph">
                  <p:embed/>
                </p:oleObj>
              </mc:Choice>
              <mc:Fallback>
                <p:oleObj name="Graph" r:id="rId3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7184" y="1202405"/>
                        <a:ext cx="2081254" cy="21612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7625843"/>
              </p:ext>
            </p:extLst>
          </p:nvPr>
        </p:nvGraphicFramePr>
        <p:xfrm>
          <a:off x="6990537" y="3659567"/>
          <a:ext cx="2081254" cy="21612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Graph" r:id="rId5" imgW="3718440" imgH="2895480" progId="Origin50.Graph">
                  <p:embed/>
                </p:oleObj>
              </mc:Choice>
              <mc:Fallback>
                <p:oleObj name="Graph" r:id="rId5" imgW="3718440" imgH="2895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90537" y="3659567"/>
                        <a:ext cx="2081254" cy="21612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9922443"/>
              </p:ext>
            </p:extLst>
          </p:nvPr>
        </p:nvGraphicFramePr>
        <p:xfrm>
          <a:off x="107185" y="3659567"/>
          <a:ext cx="2081253" cy="21612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Graph" r:id="rId7" imgW="3718440" imgH="2895480" progId="Origin50.Graph">
                  <p:embed/>
                </p:oleObj>
              </mc:Choice>
              <mc:Fallback>
                <p:oleObj name="Graph" r:id="rId7" imgW="3718440" imgH="2895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7185" y="3659567"/>
                        <a:ext cx="2081253" cy="21612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9968050"/>
              </p:ext>
            </p:extLst>
          </p:nvPr>
        </p:nvGraphicFramePr>
        <p:xfrm>
          <a:off x="1823911" y="1202405"/>
          <a:ext cx="2081254" cy="21612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Graph" r:id="rId9" imgW="3718080" imgH="2895840" progId="Origin50.Graph">
                  <p:embed/>
                </p:oleObj>
              </mc:Choice>
              <mc:Fallback>
                <p:oleObj name="Graph" r:id="rId9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823911" y="1202405"/>
                        <a:ext cx="2081254" cy="21612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7464787"/>
              </p:ext>
            </p:extLst>
          </p:nvPr>
        </p:nvGraphicFramePr>
        <p:xfrm>
          <a:off x="1823911" y="3659568"/>
          <a:ext cx="2078873" cy="21587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Graph" r:id="rId11" imgW="3718440" imgH="2895480" progId="Origin50.Graph">
                  <p:embed/>
                </p:oleObj>
              </mc:Choice>
              <mc:Fallback>
                <p:oleObj name="Graph" r:id="rId11" imgW="3718440" imgH="2895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823911" y="3659568"/>
                        <a:ext cx="2078873" cy="21587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3896814"/>
              </p:ext>
            </p:extLst>
          </p:nvPr>
        </p:nvGraphicFramePr>
        <p:xfrm>
          <a:off x="3538258" y="1199935"/>
          <a:ext cx="2083634" cy="21637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Graph" r:id="rId13" imgW="3718080" imgH="2895840" progId="Origin50.Graph">
                  <p:embed/>
                </p:oleObj>
              </mc:Choice>
              <mc:Fallback>
                <p:oleObj name="Graph" r:id="rId13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38258" y="1199935"/>
                        <a:ext cx="2083634" cy="21637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6626760"/>
              </p:ext>
            </p:extLst>
          </p:nvPr>
        </p:nvGraphicFramePr>
        <p:xfrm>
          <a:off x="3538258" y="3620560"/>
          <a:ext cx="2116436" cy="21977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Graph" r:id="rId15" imgW="3718440" imgH="2895480" progId="Origin50.Graph">
                  <p:embed/>
                </p:oleObj>
              </mc:Choice>
              <mc:Fallback>
                <p:oleObj name="Graph" r:id="rId15" imgW="3718440" imgH="2895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38258" y="3620560"/>
                        <a:ext cx="2116436" cy="21977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8942743"/>
              </p:ext>
            </p:extLst>
          </p:nvPr>
        </p:nvGraphicFramePr>
        <p:xfrm>
          <a:off x="5252604" y="1199934"/>
          <a:ext cx="2083635" cy="21637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Graph" r:id="rId17" imgW="3718080" imgH="2895840" progId="Origin50.Graph">
                  <p:embed/>
                </p:oleObj>
              </mc:Choice>
              <mc:Fallback>
                <p:oleObj name="Graph" r:id="rId17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252604" y="1199934"/>
                        <a:ext cx="2083635" cy="21637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0769994"/>
              </p:ext>
            </p:extLst>
          </p:nvPr>
        </p:nvGraphicFramePr>
        <p:xfrm>
          <a:off x="5252603" y="3620560"/>
          <a:ext cx="2116437" cy="2197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Graph" r:id="rId19" imgW="3718440" imgH="2895480" progId="Origin50.Graph">
                  <p:embed/>
                </p:oleObj>
              </mc:Choice>
              <mc:Fallback>
                <p:oleObj name="Graph" r:id="rId19" imgW="3718440" imgH="2895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252603" y="3620560"/>
                        <a:ext cx="2116437" cy="2197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3153292"/>
              </p:ext>
            </p:extLst>
          </p:nvPr>
        </p:nvGraphicFramePr>
        <p:xfrm>
          <a:off x="6990536" y="1199935"/>
          <a:ext cx="2098469" cy="2179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Graph" r:id="rId21" imgW="3718080" imgH="2895840" progId="Origin50.Graph">
                  <p:embed/>
                </p:oleObj>
              </mc:Choice>
              <mc:Fallback>
                <p:oleObj name="Graph" r:id="rId21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6990536" y="1199935"/>
                        <a:ext cx="2098469" cy="2179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828767" y="452309"/>
            <a:ext cx="85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o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439360" y="452309"/>
            <a:ext cx="11859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 </a:t>
            </a:r>
            <a:r>
              <a:rPr lang="en-US" dirty="0" err="1" smtClean="0"/>
              <a:t>nM</a:t>
            </a:r>
            <a:r>
              <a:rPr lang="en-US" dirty="0" smtClean="0"/>
              <a:t>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4119051" y="460260"/>
            <a:ext cx="1302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0 </a:t>
            </a:r>
            <a:r>
              <a:rPr lang="en-US" dirty="0" err="1" smtClean="0"/>
              <a:t>nM</a:t>
            </a:r>
            <a:r>
              <a:rPr lang="en-US" dirty="0" smtClean="0"/>
              <a:t>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5871931" y="452309"/>
            <a:ext cx="1302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0 </a:t>
            </a:r>
            <a:r>
              <a:rPr lang="en-US" dirty="0" err="1" smtClean="0"/>
              <a:t>nM</a:t>
            </a:r>
            <a:r>
              <a:rPr lang="en-US" dirty="0" smtClean="0"/>
              <a:t>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7688865" y="452857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 </a:t>
            </a:r>
            <a:r>
              <a:rPr lang="el-GR" dirty="0" smtClean="0"/>
              <a:t>μ</a:t>
            </a:r>
            <a:r>
              <a:rPr lang="en-US" dirty="0" smtClean="0"/>
              <a:t>M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00514" y="3522003"/>
            <a:ext cx="2305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a</a:t>
            </a:r>
            <a:r>
              <a:rPr lang="en-US" altLang="zh-CN" b="1" baseline="30000" dirty="0" smtClean="0"/>
              <a:t>2+</a:t>
            </a:r>
            <a:r>
              <a:rPr lang="en-US" altLang="zh-CN" b="1" dirty="0" smtClean="0"/>
              <a:t>-triggered fusion</a:t>
            </a:r>
            <a:endParaRPr lang="zh-CN" alt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08969" y="1079473"/>
            <a:ext cx="2131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Spontaneous fusion</a:t>
            </a:r>
            <a:endParaRPr lang="zh-CN" altLang="en-US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267445" y="3404381"/>
            <a:ext cx="8532171" cy="0"/>
          </a:xfrm>
          <a:prstGeom prst="line">
            <a:avLst/>
          </a:prstGeom>
          <a:ln w="381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33291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1775425"/>
              </p:ext>
            </p:extLst>
          </p:nvPr>
        </p:nvGraphicFramePr>
        <p:xfrm>
          <a:off x="314036" y="2028838"/>
          <a:ext cx="8682182" cy="254044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93697"/>
                <a:gridCol w="2156874"/>
                <a:gridCol w="1734870"/>
                <a:gridCol w="2324904"/>
                <a:gridCol w="871837"/>
              </a:tblGrid>
              <a:tr h="686246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Spontaneous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riggered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otal</a:t>
                      </a:r>
                      <a:r>
                        <a:rPr lang="en-US" baseline="0" dirty="0" smtClean="0"/>
                        <a:t> analyzed events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No 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81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3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758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6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50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n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9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63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3086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0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100 </a:t>
                      </a:r>
                      <a:r>
                        <a:rPr lang="en-US" dirty="0" err="1" smtClean="0"/>
                        <a:t>nM</a:t>
                      </a:r>
                      <a:r>
                        <a:rPr lang="en-US" dirty="0" smtClean="0"/>
                        <a:t> 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21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08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858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500 </a:t>
                      </a:r>
                      <a:r>
                        <a:rPr lang="en-US" dirty="0" err="1" smtClean="0"/>
                        <a:t>nM</a:t>
                      </a:r>
                      <a:r>
                        <a:rPr lang="en-US" dirty="0" smtClean="0"/>
                        <a:t> 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3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54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3260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6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2 µM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baseline="0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76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5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76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</a:t>
                      </a:r>
                      <a:endParaRPr lang="en-US" dirty="0"/>
                    </a:p>
                  </a:txBody>
                  <a:tcPr marL="68580" marR="6858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1529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On-screen Show (4:3)</PresentationFormat>
  <Paragraphs>36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Graph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Brunger</dc:creator>
  <cp:lastModifiedBy>Diao</cp:lastModifiedBy>
  <cp:revision>2</cp:revision>
  <dcterms:created xsi:type="dcterms:W3CDTF">2014-07-31T20:12:31Z</dcterms:created>
  <dcterms:modified xsi:type="dcterms:W3CDTF">2014-07-31T20:22:51Z</dcterms:modified>
</cp:coreProperties>
</file>